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  <p:sldId id="261" r:id="rId7"/>
    <p:sldId id="264" r:id="rId8"/>
    <p:sldId id="265" r:id="rId9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0" d="100"/>
          <a:sy n="60" d="100"/>
        </p:scale>
        <p:origin x="8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41239" y="231079"/>
            <a:ext cx="12186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8525" y="1718945"/>
            <a:ext cx="2077720" cy="158496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8599" y="3980518"/>
            <a:ext cx="2139839" cy="1521001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9219" y="4042051"/>
            <a:ext cx="2600044" cy="159807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0140" y="4042050"/>
            <a:ext cx="2092911" cy="159807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540108" y="3591439"/>
            <a:ext cx="757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372385" y="36020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N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785338" y="3527642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408327" y="1341063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20140" y="1697990"/>
            <a:ext cx="1891665" cy="162369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146422" y="132080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N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871126" y="2000204"/>
            <a:ext cx="2263816" cy="1518303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71770" y="82223"/>
            <a:ext cx="13917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5332" y="1988083"/>
            <a:ext cx="1924149" cy="135897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3776" y="2053369"/>
            <a:ext cx="2870348" cy="135897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74764" y="1544320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9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15332" y="1558631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4BD502C-6DDC-C0BA-212E-74E3A1F3F630}"/>
              </a:ext>
            </a:extLst>
          </p:cNvPr>
          <p:cNvSpPr txBox="1"/>
          <p:nvPr/>
        </p:nvSpPr>
        <p:spPr>
          <a:xfrm>
            <a:off x="3575722" y="1577019"/>
            <a:ext cx="1547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aptophys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5CD347D-FFE4-8CD9-13A9-F83F51B4465B}"/>
              </a:ext>
            </a:extLst>
          </p:cNvPr>
          <p:cNvSpPr txBox="1"/>
          <p:nvPr/>
        </p:nvSpPr>
        <p:spPr>
          <a:xfrm>
            <a:off x="3997842" y="2489934"/>
            <a:ext cx="850606" cy="4344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74193" y="177918"/>
            <a:ext cx="13917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783537" y="2233542"/>
            <a:ext cx="2721663" cy="129404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057545" y="2233542"/>
            <a:ext cx="2038455" cy="126371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098497" y="185928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N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 flipH="1">
            <a:off x="4097259" y="1767840"/>
            <a:ext cx="1135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19025" y="97109"/>
            <a:ext cx="12570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3119" y="1158036"/>
            <a:ext cx="2074482" cy="1477714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1573193" y="1166982"/>
            <a:ext cx="2358098" cy="147771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1685641" y="75072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N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245961" y="821900"/>
            <a:ext cx="1990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2108" y="5455064"/>
            <a:ext cx="1854295" cy="124466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484755" y="2937411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9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216400" y="4973320"/>
            <a:ext cx="1990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0753" y="3371515"/>
            <a:ext cx="4644655" cy="1325009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63860" y="5217841"/>
            <a:ext cx="2209800" cy="15430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D23D584-5A97-C650-8560-A8C95E3742A9}"/>
              </a:ext>
            </a:extLst>
          </p:cNvPr>
          <p:cNvSpPr txBox="1"/>
          <p:nvPr/>
        </p:nvSpPr>
        <p:spPr>
          <a:xfrm>
            <a:off x="1573192" y="4884985"/>
            <a:ext cx="1547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aptophys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CCB675B-C286-1D2A-E38D-4043FFD94F3E}"/>
              </a:ext>
            </a:extLst>
          </p:cNvPr>
          <p:cNvSpPr txBox="1"/>
          <p:nvPr/>
        </p:nvSpPr>
        <p:spPr>
          <a:xfrm>
            <a:off x="2123983" y="4027117"/>
            <a:ext cx="1809098" cy="4344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19929" y="4191634"/>
            <a:ext cx="2205935" cy="1955301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80750" y="66629"/>
            <a:ext cx="12570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</a:t>
            </a: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7291" y="1285217"/>
            <a:ext cx="2334120" cy="1705401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0892" y="1356337"/>
            <a:ext cx="2761125" cy="1705401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4745777" y="916186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635625" y="960398"/>
            <a:ext cx="1822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-caspase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492674" y="3799840"/>
            <a:ext cx="1822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-caspase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613697" y="3832106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84824" y="4300196"/>
            <a:ext cx="2133735" cy="184674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34148" y="135386"/>
            <a:ext cx="12570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900" y="1737360"/>
            <a:ext cx="2900680" cy="147574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711200" y="1375799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738880" y="137160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IV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46500" y="1721485"/>
            <a:ext cx="3342640" cy="145923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50186" y="304890"/>
            <a:ext cx="13003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650" y="1802130"/>
            <a:ext cx="3657600" cy="2534024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685800" y="132588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N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 descr="砖墙上&#10;&#10;中度可信度描述已自动生成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6612" y="1973580"/>
            <a:ext cx="3870198" cy="2207516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817876" y="1518709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595110" y="2914650"/>
            <a:ext cx="140589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98298" y="154121"/>
            <a:ext cx="13388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730" y="3910792"/>
            <a:ext cx="3610708" cy="16764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03653" y="3508449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44655" y="4580304"/>
            <a:ext cx="137845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730" y="1337205"/>
            <a:ext cx="3836086" cy="167640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72960" y="97215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9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842775" y="1905044"/>
            <a:ext cx="137845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5177" y="1384021"/>
            <a:ext cx="3476009" cy="1548717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4459178" y="930202"/>
            <a:ext cx="1547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aptophys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035341" y="2177596"/>
            <a:ext cx="127177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GJiMjUxNzNlYTc3NWIzYTYxYTU4NGViN2Q3MzFiMmU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42</Words>
  <Application>Microsoft Office PowerPoint</Application>
  <PresentationFormat>宽屏</PresentationFormat>
  <Paragraphs>3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e43554</cp:lastModifiedBy>
  <cp:revision>82</cp:revision>
  <dcterms:created xsi:type="dcterms:W3CDTF">2023-08-09T12:44:00Z</dcterms:created>
  <dcterms:modified xsi:type="dcterms:W3CDTF">2025-01-05T12:47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C28EAEEB2C14CD1893ED18D02ABDC91_13</vt:lpwstr>
  </property>
  <property fmtid="{D5CDD505-2E9C-101B-9397-08002B2CF9AE}" pid="3" name="KSOProductBuildVer">
    <vt:lpwstr>2052-12.1.0.18912</vt:lpwstr>
  </property>
</Properties>
</file>